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C0932-A8C3-406F-832B-C5CABC14FC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6B3D7-BFD4-4784-833F-A148600A91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8675F-339E-4371-9962-2E92C10428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A4CD51-BC4C-4773-98E6-EDBFB81C72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15950-B262-49B3-8D25-A1FDD50446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BE636-83EA-4E08-8320-BF2767F0C6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9BC33-2F3A-48C4-816E-D8F82B609A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57F9B-AAC4-4A64-9DEB-41A0FE78AB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15293-EDB6-4AEE-AED3-A2765BE770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9AB4E-FD76-4215-910E-5589B3716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D47559-FE4F-4D09-B146-9E34D4C742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400E5-AA6B-426F-B017-BE5ACE3503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DA82F8-6224-4B08-8419-05878E11F6AA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1"/>
          <p:cNvSpPr/>
          <p:nvPr/>
        </p:nvSpPr>
        <p:spPr>
          <a:xfrm>
            <a:off x="281880" y="272880"/>
            <a:ext cx="642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200" spc="-1" strike="noStrike">
                <a:solidFill>
                  <a:srgbClr val="000000"/>
                </a:solidFill>
                <a:latin typeface="Arial"/>
              </a:rPr>
              <a:t>Table S2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titumor activities obtained in pancreatic models upon K-RAS knock d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04640" y="631800"/>
          <a:ext cx="6162840" cy="4998960"/>
        </p:xfrm>
        <a:graphic>
          <a:graphicData uri="http://schemas.openxmlformats.org/drawingml/2006/table">
            <a:tbl>
              <a:tblPr/>
              <a:tblGrid>
                <a:gridCol w="1049400"/>
                <a:gridCol w="863640"/>
                <a:gridCol w="792360"/>
                <a:gridCol w="720720"/>
                <a:gridCol w="792000"/>
                <a:gridCol w="936720"/>
                <a:gridCol w="1008000"/>
              </a:tblGrid>
              <a:tr h="54936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eatme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ubling time / 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/C day 18 / 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/C last day / 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∆ </a:t>
                      </a: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mor volume / mm</a:t>
                      </a:r>
                      <a:r>
                        <a:rPr b="0" lang="de-CH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UC / mm</a:t>
                      </a:r>
                      <a:r>
                        <a:rPr b="0" lang="de-CH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x treatment day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pan-1 sh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6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pan-1 sh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7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pan-1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7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pan-1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1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4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21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10.05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nc10.05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96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3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PC-1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1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PC-1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4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91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3.3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7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3.3 sh2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648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7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46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437 sh236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437 sh236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af-ZA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05*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400" marR="5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CH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9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7T07:31:12Z</dcterms:created>
  <dc:creator>hofmair1</dc:creator>
  <dc:description/>
  <dc:language>en-US</dc:language>
  <cp:lastModifiedBy>hofmair1</cp:lastModifiedBy>
  <dcterms:modified xsi:type="dcterms:W3CDTF">2012-03-18T13:37:59Z</dcterms:modified>
  <cp:revision>27</cp:revision>
  <dc:subject/>
  <dc:title>Slide 1</dc:title>
</cp:coreProperties>
</file>